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3" r:id="rId2"/>
    <p:sldId id="264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000" autoAdjust="0"/>
    <p:restoredTop sz="94660"/>
  </p:normalViewPr>
  <p:slideViewPr>
    <p:cSldViewPr snapToGrid="0">
      <p:cViewPr varScale="1">
        <p:scale>
          <a:sx n="93" d="100"/>
          <a:sy n="93" d="100"/>
        </p:scale>
        <p:origin x="93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二村　学" userId="a7c8e87e-af6a-417d-9add-d17dbf2ca80b" providerId="ADAL" clId="{00C2AF07-3994-467F-B3CB-E7C18CDC785F}"/>
    <pc:docChg chg="delSld">
      <pc:chgData name="二村　学" userId="a7c8e87e-af6a-417d-9add-d17dbf2ca80b" providerId="ADAL" clId="{00C2AF07-3994-467F-B3CB-E7C18CDC785F}" dt="2025-07-30T14:46:39.308" v="3" actId="47"/>
      <pc:docMkLst>
        <pc:docMk/>
      </pc:docMkLst>
      <pc:sldChg chg="del">
        <pc:chgData name="二村　学" userId="a7c8e87e-af6a-417d-9add-d17dbf2ca80b" providerId="ADAL" clId="{00C2AF07-3994-467F-B3CB-E7C18CDC785F}" dt="2025-07-30T14:46:39.308" v="3" actId="47"/>
        <pc:sldMkLst>
          <pc:docMk/>
          <pc:sldMk cId="847387654" sldId="259"/>
        </pc:sldMkLst>
      </pc:sldChg>
      <pc:sldChg chg="del">
        <pc:chgData name="二村　学" userId="a7c8e87e-af6a-417d-9add-d17dbf2ca80b" providerId="ADAL" clId="{00C2AF07-3994-467F-B3CB-E7C18CDC785F}" dt="2025-07-30T14:46:35.838" v="0" actId="47"/>
        <pc:sldMkLst>
          <pc:docMk/>
          <pc:sldMk cId="66776088" sldId="260"/>
        </pc:sldMkLst>
      </pc:sldChg>
      <pc:sldChg chg="del">
        <pc:chgData name="二村　学" userId="a7c8e87e-af6a-417d-9add-d17dbf2ca80b" providerId="ADAL" clId="{00C2AF07-3994-467F-B3CB-E7C18CDC785F}" dt="2025-07-30T14:46:38.210" v="2" actId="47"/>
        <pc:sldMkLst>
          <pc:docMk/>
          <pc:sldMk cId="163787298" sldId="261"/>
        </pc:sldMkLst>
      </pc:sldChg>
      <pc:sldChg chg="del">
        <pc:chgData name="二村　学" userId="a7c8e87e-af6a-417d-9add-d17dbf2ca80b" providerId="ADAL" clId="{00C2AF07-3994-467F-B3CB-E7C18CDC785F}" dt="2025-07-30T14:46:37.011" v="1" actId="47"/>
        <pc:sldMkLst>
          <pc:docMk/>
          <pc:sldMk cId="996428416" sldId="26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3322CA-6B63-4DF8-92CB-937E952017F7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7FBB2B-78AB-4229-A599-A6B7602B9C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039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7FBB2B-78AB-4229-A599-A6B7602B9CC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37184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0F6A36-5103-4A5B-66A5-32C71146B4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DEDC6E03-A735-64DD-6890-2719110E96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E9FD11-039F-26C3-A576-79B03654F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6C1192-8510-AC2F-D4CD-C049981166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9791BD-C2E2-9DA5-5CD7-C8D1FFBEA2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5691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D195A0-1485-7A78-C24A-43A0E3B89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6A61B35-7CEF-8AC4-0176-91F513BD60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F263FB8-AF37-7DD6-CA54-571694229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126E9EB-7779-AFC8-4D36-408D069C86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B1F823B-71F0-17A3-B72D-1DF8FAC6AF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986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011C599-309E-1355-70DE-B1B0AB5F6D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662381B-15F3-C0C4-0720-FCC5D71643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983150-F36D-A743-7A83-075AC4CDFF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8DCFC3-DD7E-A548-5B2E-3B41C8CD1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B0F24E-B77B-A05D-921B-358066705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142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1BD70E-DA16-4811-3748-32D5ADBFBD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91C5474-87BF-907D-F1A9-69CE129C4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84C2216-D244-AAAD-8283-2F320B4AE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3C4CDC-7D81-8E26-510F-12083B14D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F115FE5-9A7A-1BD9-3FAA-C6AA91263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4464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CF7D36-ED35-B941-DE1D-B2AE0E0485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030110-D88D-A67D-5A6A-4A0224B6C3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4D0FB1-9848-3C9D-203C-4A4087C622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D24C302-1B90-CEF9-7BD7-47F46B4418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185AA1A-A652-34D7-AE28-697C6DA955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061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6E132B-669C-108B-5B78-1A3FEFF8F8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51ACE5E-6B32-47BB-631B-690ED05F6F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0AF5EED-AA48-85FD-D00D-8BC00EE790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9A4979B-B8A2-E32D-30CA-1A562C8CE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75A2555-4953-9673-8FE5-67EB1C80B8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604244B-1B12-1B96-DF32-79BC57B938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20163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B7C53E-0D57-0A8C-25ED-EF0C8047AA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4409C56-063A-5FA0-E046-CDEA2B5D7F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782C7AC-F331-9C44-3C6A-2698DA6F80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068A723-5C91-6707-9E6F-8ADC250DF1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899EF6F-9199-872F-0432-184F43524D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8F69361-38FA-A056-76DF-8B9A1661A2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F7F74F2-BD80-CF1D-3F17-20CF25B5E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107FAE0-152A-5057-C52C-A60A21A50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201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27C329-313E-14F9-514A-E6765ADB6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59CA8CF4-1E05-9DF5-E98D-018904394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D55D6E1C-ADB4-9225-4D16-B6F928F1DC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2D01103-92D9-C1D4-680C-2ECC8C405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7041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72AD486-2C36-EE65-3ECC-16A00AACB3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33D9B44-6479-F68F-47DB-BAD0A6D865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DAD8A74-BCBD-2F3E-1A38-54694BE236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31608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354031-E058-F873-C433-B20E619B65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2CE8565-E0AB-D93D-1032-136B1BF272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7EF716B-01C6-4C50-884E-5ADF3260AC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F164A7D-42C4-C0C5-6B83-A7C67C26D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4D64304-44E1-DDA3-7F4F-0DD33744B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99E3163-2442-F457-609A-9DB268F84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7791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E612A3-F004-0F97-D771-C2701E8E36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F68921D-02BC-CC2B-7B93-D2CB5F1CA30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068BB43-32BD-47A1-3A67-B69936D932D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65B66FC-8559-B13A-AD5D-C604B62BA6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729A0E8-69B1-3A02-B3BB-C5B07D26B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51608B3-403E-2D7E-E0E5-6A450FBEF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62846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E96A262-C202-97BF-229F-6C7C730AD0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9D3381-2DC2-4228-B9A6-F7156A289E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CC68506-DD4C-7B5C-81D7-CDBB51AEC6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4FB2F2-F732-4D32-986F-894493B11A48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E1416FD-6C59-52F1-9392-1C2E2C51A95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3C57C4F-FABE-A99A-5137-0725CCCF56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D51AC0-19A9-4AF2-BDFF-4122734080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387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603283C-FA07-5364-596C-615948EF86DE}"/>
              </a:ext>
            </a:extLst>
          </p:cNvPr>
          <p:cNvSpPr txBox="1"/>
          <p:nvPr/>
        </p:nvSpPr>
        <p:spPr>
          <a:xfrm>
            <a:off x="9577679" y="1666180"/>
            <a:ext cx="14421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D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  　　　　　　　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ADBB6E2-AA00-80E3-D8A5-086BB3F46973}"/>
              </a:ext>
            </a:extLst>
          </p:cNvPr>
          <p:cNvSpPr txBox="1"/>
          <p:nvPr/>
        </p:nvSpPr>
        <p:spPr>
          <a:xfrm>
            <a:off x="7021986" y="1666180"/>
            <a:ext cx="13208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C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 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907B863-B8F9-7AB6-4C81-D2A2A6FCF0A5}"/>
              </a:ext>
            </a:extLst>
          </p:cNvPr>
          <p:cNvSpPr txBox="1"/>
          <p:nvPr/>
        </p:nvSpPr>
        <p:spPr>
          <a:xfrm>
            <a:off x="4424371" y="1666180"/>
            <a:ext cx="11799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B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9A0FA2B-2EFF-ECCD-EEDF-CF4E5D329AC9}"/>
              </a:ext>
            </a:extLst>
          </p:cNvPr>
          <p:cNvSpPr txBox="1"/>
          <p:nvPr/>
        </p:nvSpPr>
        <p:spPr>
          <a:xfrm>
            <a:off x="1984645" y="1666180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A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E344260-3827-7CBF-C5FF-D842BE5C7A6E}"/>
              </a:ext>
            </a:extLst>
          </p:cNvPr>
          <p:cNvSpPr txBox="1"/>
          <p:nvPr/>
        </p:nvSpPr>
        <p:spPr>
          <a:xfrm>
            <a:off x="523751" y="2502343"/>
            <a:ext cx="647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884EC13-4121-6C3F-BBBF-7F0685E01E88}"/>
              </a:ext>
            </a:extLst>
          </p:cNvPr>
          <p:cNvSpPr txBox="1"/>
          <p:nvPr/>
        </p:nvSpPr>
        <p:spPr>
          <a:xfrm>
            <a:off x="523751" y="4401342"/>
            <a:ext cx="647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RI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2250886C-9F91-7AB4-E111-4D18CEDAF4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1255" y="3935683"/>
            <a:ext cx="2467319" cy="1314633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5E1E7436-8C50-A9AE-8A89-FF265170864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1255" y="1949794"/>
            <a:ext cx="2467319" cy="1413318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2D787CA2-6044-B61E-103D-1B6D8214A2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47682" y="3935683"/>
            <a:ext cx="2467319" cy="1314633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829E14CC-2F95-ECEC-22D9-FB70B7AFCB1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847682" y="1949794"/>
            <a:ext cx="2467319" cy="1413318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E20A6087-D5E1-14C3-C682-7BE109C521D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93203" y="3935683"/>
            <a:ext cx="2467319" cy="1321037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28D36939-D42C-4813-847B-2C627D09CA6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93203" y="1949794"/>
            <a:ext cx="2467319" cy="1413318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C56038D-0C55-4C05-5B8E-7A82F9C49A1F}"/>
              </a:ext>
            </a:extLst>
          </p:cNvPr>
          <p:cNvSpPr txBox="1"/>
          <p:nvPr/>
        </p:nvSpPr>
        <p:spPr>
          <a:xfrm>
            <a:off x="1974867" y="3373386"/>
            <a:ext cx="1072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7*15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49F69A8-1F82-C6BA-3603-638F49E5BD8E}"/>
              </a:ext>
            </a:extLst>
          </p:cNvPr>
          <p:cNvSpPr txBox="1"/>
          <p:nvPr/>
        </p:nvSpPr>
        <p:spPr>
          <a:xfrm>
            <a:off x="4551969" y="3351894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4*18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DE986F2-6D55-AAA7-DAB0-6192E2A66F31}"/>
              </a:ext>
            </a:extLst>
          </p:cNvPr>
          <p:cNvSpPr txBox="1"/>
          <p:nvPr/>
        </p:nvSpPr>
        <p:spPr>
          <a:xfrm>
            <a:off x="7012209" y="3334703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7*17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5BAB941-5EB8-6F52-CEA5-438CC84683C8}"/>
              </a:ext>
            </a:extLst>
          </p:cNvPr>
          <p:cNvSpPr txBox="1"/>
          <p:nvPr/>
        </p:nvSpPr>
        <p:spPr>
          <a:xfrm>
            <a:off x="9628552" y="3334703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1*22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B8F529A-045C-753C-EC4A-2B380F3C1C77}"/>
              </a:ext>
            </a:extLst>
          </p:cNvPr>
          <p:cNvSpPr txBox="1"/>
          <p:nvPr/>
        </p:nvSpPr>
        <p:spPr>
          <a:xfrm>
            <a:off x="1974867" y="5263637"/>
            <a:ext cx="1072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1*18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85C384A-3463-2B95-62D2-C38C726611F3}"/>
              </a:ext>
            </a:extLst>
          </p:cNvPr>
          <p:cNvSpPr txBox="1"/>
          <p:nvPr/>
        </p:nvSpPr>
        <p:spPr>
          <a:xfrm>
            <a:off x="4551969" y="5242145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6*21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0CB0A4E9-2E73-4114-F1A5-311CB93D46CB}"/>
              </a:ext>
            </a:extLst>
          </p:cNvPr>
          <p:cNvSpPr txBox="1"/>
          <p:nvPr/>
        </p:nvSpPr>
        <p:spPr>
          <a:xfrm>
            <a:off x="7012209" y="5224954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3*26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DBA9558-EC8B-FA37-C575-FFBCF0F108CD}"/>
              </a:ext>
            </a:extLst>
          </p:cNvPr>
          <p:cNvSpPr txBox="1"/>
          <p:nvPr/>
        </p:nvSpPr>
        <p:spPr>
          <a:xfrm>
            <a:off x="9628552" y="5224954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35*27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図 39">
            <a:extLst>
              <a:ext uri="{FF2B5EF4-FFF2-40B4-BE49-F238E27FC236}">
                <a16:creationId xmlns:a16="http://schemas.microsoft.com/office/drawing/2014/main" id="{CA4A84FC-66D0-DE0C-B6F6-E7749B5E96B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37366" y="3949838"/>
            <a:ext cx="2467319" cy="1327954"/>
          </a:xfrm>
          <a:prstGeom prst="rect">
            <a:avLst/>
          </a:prstGeom>
        </p:spPr>
      </p:pic>
      <p:pic>
        <p:nvPicPr>
          <p:cNvPr id="42" name="図 41">
            <a:extLst>
              <a:ext uri="{FF2B5EF4-FFF2-40B4-BE49-F238E27FC236}">
                <a16:creationId xmlns:a16="http://schemas.microsoft.com/office/drawing/2014/main" id="{D3DE8E34-1E67-4972-159F-2521EB061DD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715474" y="1949794"/>
            <a:ext cx="2489211" cy="1413318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6C91B6E-DB64-40A3-857A-BE8BAE6A6864}"/>
              </a:ext>
            </a:extLst>
          </p:cNvPr>
          <p:cNvSpPr txBox="1"/>
          <p:nvPr/>
        </p:nvSpPr>
        <p:spPr>
          <a:xfrm>
            <a:off x="1334709" y="57749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 Fig.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矢印: 右 1">
            <a:extLst>
              <a:ext uri="{FF2B5EF4-FFF2-40B4-BE49-F238E27FC236}">
                <a16:creationId xmlns:a16="http://schemas.microsoft.com/office/drawing/2014/main" id="{51FA1F1F-454F-F152-5D12-E47FB27BCA05}"/>
              </a:ext>
            </a:extLst>
          </p:cNvPr>
          <p:cNvSpPr/>
          <p:nvPr/>
        </p:nvSpPr>
        <p:spPr>
          <a:xfrm rot="3426325">
            <a:off x="1396841" y="2155831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矢印: 右 14">
            <a:extLst>
              <a:ext uri="{FF2B5EF4-FFF2-40B4-BE49-F238E27FC236}">
                <a16:creationId xmlns:a16="http://schemas.microsoft.com/office/drawing/2014/main" id="{2EB011FB-FF06-3BB6-4386-0E6D50FAF3A0}"/>
              </a:ext>
            </a:extLst>
          </p:cNvPr>
          <p:cNvSpPr/>
          <p:nvPr/>
        </p:nvSpPr>
        <p:spPr>
          <a:xfrm rot="7708484">
            <a:off x="2136449" y="2121017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矢印: 右 15">
            <a:extLst>
              <a:ext uri="{FF2B5EF4-FFF2-40B4-BE49-F238E27FC236}">
                <a16:creationId xmlns:a16="http://schemas.microsoft.com/office/drawing/2014/main" id="{FA41E3EC-DA5A-B55A-07E7-8973A0634337}"/>
              </a:ext>
            </a:extLst>
          </p:cNvPr>
          <p:cNvSpPr/>
          <p:nvPr/>
        </p:nvSpPr>
        <p:spPr>
          <a:xfrm rot="3426325">
            <a:off x="2572506" y="2155830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矢印: 右 16">
            <a:extLst>
              <a:ext uri="{FF2B5EF4-FFF2-40B4-BE49-F238E27FC236}">
                <a16:creationId xmlns:a16="http://schemas.microsoft.com/office/drawing/2014/main" id="{060D1B88-70B7-4650-558A-44BD1EB0B3F8}"/>
              </a:ext>
            </a:extLst>
          </p:cNvPr>
          <p:cNvSpPr/>
          <p:nvPr/>
        </p:nvSpPr>
        <p:spPr>
          <a:xfrm rot="7708484">
            <a:off x="3312114" y="2121016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矢印: 右 17">
            <a:extLst>
              <a:ext uri="{FF2B5EF4-FFF2-40B4-BE49-F238E27FC236}">
                <a16:creationId xmlns:a16="http://schemas.microsoft.com/office/drawing/2014/main" id="{895D7CCB-D666-41B7-51A2-EE7E7131DAF8}"/>
              </a:ext>
            </a:extLst>
          </p:cNvPr>
          <p:cNvSpPr/>
          <p:nvPr/>
        </p:nvSpPr>
        <p:spPr>
          <a:xfrm rot="3426325">
            <a:off x="3942439" y="2110288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矢印: 右 18">
            <a:extLst>
              <a:ext uri="{FF2B5EF4-FFF2-40B4-BE49-F238E27FC236}">
                <a16:creationId xmlns:a16="http://schemas.microsoft.com/office/drawing/2014/main" id="{8734AD23-1A1C-1994-0F4B-766AF3C1DF14}"/>
              </a:ext>
            </a:extLst>
          </p:cNvPr>
          <p:cNvSpPr/>
          <p:nvPr/>
        </p:nvSpPr>
        <p:spPr>
          <a:xfrm rot="7708484">
            <a:off x="4682047" y="2075474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矢印: 右 20">
            <a:extLst>
              <a:ext uri="{FF2B5EF4-FFF2-40B4-BE49-F238E27FC236}">
                <a16:creationId xmlns:a16="http://schemas.microsoft.com/office/drawing/2014/main" id="{D3F338A7-CFC7-BD56-2F10-CF983A0366E7}"/>
              </a:ext>
            </a:extLst>
          </p:cNvPr>
          <p:cNvSpPr/>
          <p:nvPr/>
        </p:nvSpPr>
        <p:spPr>
          <a:xfrm rot="3426325">
            <a:off x="5118104" y="2110287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矢印: 右 22">
            <a:extLst>
              <a:ext uri="{FF2B5EF4-FFF2-40B4-BE49-F238E27FC236}">
                <a16:creationId xmlns:a16="http://schemas.microsoft.com/office/drawing/2014/main" id="{D301BF74-E24E-D84F-7CB3-02715AFE801D}"/>
              </a:ext>
            </a:extLst>
          </p:cNvPr>
          <p:cNvSpPr/>
          <p:nvPr/>
        </p:nvSpPr>
        <p:spPr>
          <a:xfrm rot="7708484">
            <a:off x="5928779" y="2103173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矢印: 右 24">
            <a:extLst>
              <a:ext uri="{FF2B5EF4-FFF2-40B4-BE49-F238E27FC236}">
                <a16:creationId xmlns:a16="http://schemas.microsoft.com/office/drawing/2014/main" id="{B4DDBB7E-E875-77C2-6C46-648453B42676}"/>
              </a:ext>
            </a:extLst>
          </p:cNvPr>
          <p:cNvSpPr/>
          <p:nvPr/>
        </p:nvSpPr>
        <p:spPr>
          <a:xfrm rot="3426325">
            <a:off x="6497156" y="2196582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矢印: 右 26">
            <a:extLst>
              <a:ext uri="{FF2B5EF4-FFF2-40B4-BE49-F238E27FC236}">
                <a16:creationId xmlns:a16="http://schemas.microsoft.com/office/drawing/2014/main" id="{770B9A44-5C1B-80A8-AEF0-4F82EDB8CC6F}"/>
              </a:ext>
            </a:extLst>
          </p:cNvPr>
          <p:cNvSpPr/>
          <p:nvPr/>
        </p:nvSpPr>
        <p:spPr>
          <a:xfrm rot="7708484">
            <a:off x="7318017" y="2194283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8" name="矢印: 右 27">
            <a:extLst>
              <a:ext uri="{FF2B5EF4-FFF2-40B4-BE49-F238E27FC236}">
                <a16:creationId xmlns:a16="http://schemas.microsoft.com/office/drawing/2014/main" id="{8E2CF303-58B8-8336-88F2-ECE81DBA4300}"/>
              </a:ext>
            </a:extLst>
          </p:cNvPr>
          <p:cNvSpPr/>
          <p:nvPr/>
        </p:nvSpPr>
        <p:spPr>
          <a:xfrm rot="3426325">
            <a:off x="7672821" y="2196581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矢印: 右 29">
            <a:extLst>
              <a:ext uri="{FF2B5EF4-FFF2-40B4-BE49-F238E27FC236}">
                <a16:creationId xmlns:a16="http://schemas.microsoft.com/office/drawing/2014/main" id="{351EB599-3FDB-C071-FB38-80D17D780928}"/>
              </a:ext>
            </a:extLst>
          </p:cNvPr>
          <p:cNvSpPr/>
          <p:nvPr/>
        </p:nvSpPr>
        <p:spPr>
          <a:xfrm rot="7708484">
            <a:off x="8483496" y="2189467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矢印: 右 30">
            <a:extLst>
              <a:ext uri="{FF2B5EF4-FFF2-40B4-BE49-F238E27FC236}">
                <a16:creationId xmlns:a16="http://schemas.microsoft.com/office/drawing/2014/main" id="{64F95C37-E662-3162-EED7-28280DD4E62F}"/>
              </a:ext>
            </a:extLst>
          </p:cNvPr>
          <p:cNvSpPr/>
          <p:nvPr/>
        </p:nvSpPr>
        <p:spPr>
          <a:xfrm rot="3426325">
            <a:off x="8994978" y="2272381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9" name="矢印: 右 38">
            <a:extLst>
              <a:ext uri="{FF2B5EF4-FFF2-40B4-BE49-F238E27FC236}">
                <a16:creationId xmlns:a16="http://schemas.microsoft.com/office/drawing/2014/main" id="{E90F4ED8-0157-5863-267E-25A047DA7047}"/>
              </a:ext>
            </a:extLst>
          </p:cNvPr>
          <p:cNvSpPr/>
          <p:nvPr/>
        </p:nvSpPr>
        <p:spPr>
          <a:xfrm rot="7708484">
            <a:off x="9830191" y="2270085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矢印: 右 40">
            <a:extLst>
              <a:ext uri="{FF2B5EF4-FFF2-40B4-BE49-F238E27FC236}">
                <a16:creationId xmlns:a16="http://schemas.microsoft.com/office/drawing/2014/main" id="{D62F1632-8BCC-5DB1-E989-DD85D9C3A41F}"/>
              </a:ext>
            </a:extLst>
          </p:cNvPr>
          <p:cNvSpPr/>
          <p:nvPr/>
        </p:nvSpPr>
        <p:spPr>
          <a:xfrm rot="3426325">
            <a:off x="10310565" y="2331387"/>
            <a:ext cx="145042" cy="45719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矢印: 右 42">
            <a:extLst>
              <a:ext uri="{FF2B5EF4-FFF2-40B4-BE49-F238E27FC236}">
                <a16:creationId xmlns:a16="http://schemas.microsoft.com/office/drawing/2014/main" id="{575C1162-4E41-6F61-5FD8-C466E916CA81}"/>
              </a:ext>
            </a:extLst>
          </p:cNvPr>
          <p:cNvSpPr/>
          <p:nvPr/>
        </p:nvSpPr>
        <p:spPr>
          <a:xfrm rot="7708484">
            <a:off x="11095139" y="2270084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矢印: 右 43">
            <a:extLst>
              <a:ext uri="{FF2B5EF4-FFF2-40B4-BE49-F238E27FC236}">
                <a16:creationId xmlns:a16="http://schemas.microsoft.com/office/drawing/2014/main" id="{E9430328-F43C-CA95-564F-CF60AC32DB42}"/>
              </a:ext>
            </a:extLst>
          </p:cNvPr>
          <p:cNvSpPr/>
          <p:nvPr/>
        </p:nvSpPr>
        <p:spPr>
          <a:xfrm rot="3426325">
            <a:off x="1531042" y="4416368"/>
            <a:ext cx="170636" cy="69433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矢印: 右 44">
            <a:extLst>
              <a:ext uri="{FF2B5EF4-FFF2-40B4-BE49-F238E27FC236}">
                <a16:creationId xmlns:a16="http://schemas.microsoft.com/office/drawing/2014/main" id="{7D950498-0BEA-2A87-074F-33AC8A3479FA}"/>
              </a:ext>
            </a:extLst>
          </p:cNvPr>
          <p:cNvSpPr/>
          <p:nvPr/>
        </p:nvSpPr>
        <p:spPr>
          <a:xfrm rot="3426325">
            <a:off x="4185671" y="4378847"/>
            <a:ext cx="170636" cy="69433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矢印: 右 45">
            <a:extLst>
              <a:ext uri="{FF2B5EF4-FFF2-40B4-BE49-F238E27FC236}">
                <a16:creationId xmlns:a16="http://schemas.microsoft.com/office/drawing/2014/main" id="{B071466E-BBA2-61F8-BACD-D6B8D7E7211E}"/>
              </a:ext>
            </a:extLst>
          </p:cNvPr>
          <p:cNvSpPr/>
          <p:nvPr/>
        </p:nvSpPr>
        <p:spPr>
          <a:xfrm rot="3426325">
            <a:off x="6447642" y="4303831"/>
            <a:ext cx="170636" cy="69433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7" name="矢印: 右 46">
            <a:extLst>
              <a:ext uri="{FF2B5EF4-FFF2-40B4-BE49-F238E27FC236}">
                <a16:creationId xmlns:a16="http://schemas.microsoft.com/office/drawing/2014/main" id="{8C0AC773-3945-E04D-7C6D-9DF5C25C10F0}"/>
              </a:ext>
            </a:extLst>
          </p:cNvPr>
          <p:cNvSpPr/>
          <p:nvPr/>
        </p:nvSpPr>
        <p:spPr>
          <a:xfrm rot="3426325">
            <a:off x="9109218" y="4235381"/>
            <a:ext cx="170636" cy="69433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28597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5169E8CB-69A0-5B16-78E5-7BAC9E289BC9}"/>
              </a:ext>
            </a:extLst>
          </p:cNvPr>
          <p:cNvSpPr txBox="1"/>
          <p:nvPr/>
        </p:nvSpPr>
        <p:spPr>
          <a:xfrm>
            <a:off x="1334709" y="577490"/>
            <a:ext cx="21723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Supplement Fig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ja-JP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A1C3A25-F2FF-D1E9-45AE-0A8752D22CE9}"/>
              </a:ext>
            </a:extLst>
          </p:cNvPr>
          <p:cNvSpPr txBox="1"/>
          <p:nvPr/>
        </p:nvSpPr>
        <p:spPr>
          <a:xfrm>
            <a:off x="2822359" y="4587770"/>
            <a:ext cx="647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S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FB0281F-A461-9AE4-F072-2E318ABF8CA6}"/>
              </a:ext>
            </a:extLst>
          </p:cNvPr>
          <p:cNvSpPr txBox="1"/>
          <p:nvPr/>
        </p:nvSpPr>
        <p:spPr>
          <a:xfrm>
            <a:off x="2738247" y="2698669"/>
            <a:ext cx="6475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MRI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B9443C03-86A5-C0E3-1128-75788CBDE6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28681" y="2137744"/>
            <a:ext cx="2467319" cy="1384909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C7EA2E1D-BE6B-BBE6-D411-F5BCFCEB2F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28681" y="4104042"/>
            <a:ext cx="2467319" cy="1347887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80578E1-EEFC-09BC-CE54-2B3AF92A76D1}"/>
              </a:ext>
            </a:extLst>
          </p:cNvPr>
          <p:cNvSpPr txBox="1"/>
          <p:nvPr/>
        </p:nvSpPr>
        <p:spPr>
          <a:xfrm>
            <a:off x="4544699" y="3528202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9*15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906F8AA-880B-44EA-D563-D1356C20AD2F}"/>
              </a:ext>
            </a:extLst>
          </p:cNvPr>
          <p:cNvSpPr txBox="1"/>
          <p:nvPr/>
        </p:nvSpPr>
        <p:spPr>
          <a:xfrm>
            <a:off x="4544699" y="5418453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8*17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0A627A3-C14D-AE28-059F-CB2AF12BEEA5}"/>
              </a:ext>
            </a:extLst>
          </p:cNvPr>
          <p:cNvSpPr txBox="1"/>
          <p:nvPr/>
        </p:nvSpPr>
        <p:spPr>
          <a:xfrm>
            <a:off x="4082078" y="1393531"/>
            <a:ext cx="157376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68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yo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A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 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A50DBBD8-F4CB-0A4E-75A3-D8CE2B16DC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85786" y="2132195"/>
            <a:ext cx="2467319" cy="1370573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D2B758FE-6CBD-2485-1B10-62824E6EF7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5786" y="4098493"/>
            <a:ext cx="2467319" cy="1347887"/>
          </a:xfrm>
          <a:prstGeom prst="rect">
            <a:avLst/>
          </a:prstGeom>
        </p:spPr>
      </p:pic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7BCEA776-FC97-07EB-E55E-DCA5A87DCB54}"/>
              </a:ext>
            </a:extLst>
          </p:cNvPr>
          <p:cNvSpPr txBox="1"/>
          <p:nvPr/>
        </p:nvSpPr>
        <p:spPr>
          <a:xfrm>
            <a:off x="6986434" y="3502768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19*16</a:t>
            </a:r>
            <a:r>
              <a:rPr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4665B30-F431-B04F-F0E4-4C96F6C0964D}"/>
              </a:ext>
            </a:extLst>
          </p:cNvPr>
          <p:cNvSpPr txBox="1"/>
          <p:nvPr/>
        </p:nvSpPr>
        <p:spPr>
          <a:xfrm>
            <a:off x="6986434" y="5393019"/>
            <a:ext cx="13208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*18 mm</a:t>
            </a:r>
            <a:endParaRPr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EFC1D2F-48DF-854D-EAE3-10214C7DEB44}"/>
              </a:ext>
            </a:extLst>
          </p:cNvPr>
          <p:cNvSpPr txBox="1"/>
          <p:nvPr/>
        </p:nvSpPr>
        <p:spPr>
          <a:xfrm>
            <a:off x="6812874" y="1400790"/>
            <a:ext cx="157376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ase 2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kumimoji="1" lang="en-US" altLang="ja-JP" sz="1400" dirty="0" err="1">
                <a:latin typeface="Arial" panose="020B0604020202020204" pitchFamily="34" charset="0"/>
                <a:cs typeface="Arial" panose="020B0604020202020204" pitchFamily="34" charset="0"/>
              </a:rPr>
              <a:t>yo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Category B</a:t>
            </a:r>
            <a:r>
              <a: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　 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矢印: 右 29">
            <a:extLst>
              <a:ext uri="{FF2B5EF4-FFF2-40B4-BE49-F238E27FC236}">
                <a16:creationId xmlns:a16="http://schemas.microsoft.com/office/drawing/2014/main" id="{39B2D26D-1B15-DCA5-B126-FE12932F0E13}"/>
              </a:ext>
            </a:extLst>
          </p:cNvPr>
          <p:cNvSpPr/>
          <p:nvPr/>
        </p:nvSpPr>
        <p:spPr>
          <a:xfrm rot="3426325">
            <a:off x="3870451" y="4478006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矢印: 右 30">
            <a:extLst>
              <a:ext uri="{FF2B5EF4-FFF2-40B4-BE49-F238E27FC236}">
                <a16:creationId xmlns:a16="http://schemas.microsoft.com/office/drawing/2014/main" id="{48133AB7-F2F5-ADF1-8402-E1685C9AB1DF}"/>
              </a:ext>
            </a:extLst>
          </p:cNvPr>
          <p:cNvSpPr/>
          <p:nvPr/>
        </p:nvSpPr>
        <p:spPr>
          <a:xfrm rot="7708484">
            <a:off x="4533876" y="4500549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矢印: 右 31">
            <a:extLst>
              <a:ext uri="{FF2B5EF4-FFF2-40B4-BE49-F238E27FC236}">
                <a16:creationId xmlns:a16="http://schemas.microsoft.com/office/drawing/2014/main" id="{42095D6C-331E-999E-7327-006C22FA2A94}"/>
              </a:ext>
            </a:extLst>
          </p:cNvPr>
          <p:cNvSpPr/>
          <p:nvPr/>
        </p:nvSpPr>
        <p:spPr>
          <a:xfrm rot="3426325">
            <a:off x="5103226" y="4478005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3" name="矢印: 右 32">
            <a:extLst>
              <a:ext uri="{FF2B5EF4-FFF2-40B4-BE49-F238E27FC236}">
                <a16:creationId xmlns:a16="http://schemas.microsoft.com/office/drawing/2014/main" id="{D932B3C8-3CD6-7A32-199D-50F38CF9F2B1}"/>
              </a:ext>
            </a:extLst>
          </p:cNvPr>
          <p:cNvSpPr/>
          <p:nvPr/>
        </p:nvSpPr>
        <p:spPr>
          <a:xfrm rot="7708484">
            <a:off x="5652427" y="4497050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4" name="矢印: 右 33">
            <a:extLst>
              <a:ext uri="{FF2B5EF4-FFF2-40B4-BE49-F238E27FC236}">
                <a16:creationId xmlns:a16="http://schemas.microsoft.com/office/drawing/2014/main" id="{7156A7B0-882C-9C80-D7E1-776CF181BB74}"/>
              </a:ext>
            </a:extLst>
          </p:cNvPr>
          <p:cNvSpPr/>
          <p:nvPr/>
        </p:nvSpPr>
        <p:spPr>
          <a:xfrm rot="3426325">
            <a:off x="5493443" y="2663953"/>
            <a:ext cx="170636" cy="69433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1" name="矢印: 右 40">
            <a:extLst>
              <a:ext uri="{FF2B5EF4-FFF2-40B4-BE49-F238E27FC236}">
                <a16:creationId xmlns:a16="http://schemas.microsoft.com/office/drawing/2014/main" id="{F5CD5D70-71C7-9654-A453-2996C59D0093}"/>
              </a:ext>
            </a:extLst>
          </p:cNvPr>
          <p:cNvSpPr/>
          <p:nvPr/>
        </p:nvSpPr>
        <p:spPr>
          <a:xfrm rot="3426325">
            <a:off x="6436070" y="2738077"/>
            <a:ext cx="170636" cy="69433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2" name="矢印: 右 41">
            <a:extLst>
              <a:ext uri="{FF2B5EF4-FFF2-40B4-BE49-F238E27FC236}">
                <a16:creationId xmlns:a16="http://schemas.microsoft.com/office/drawing/2014/main" id="{055EBEB0-FB0F-DD8C-83D9-A16DE360B795}"/>
              </a:ext>
            </a:extLst>
          </p:cNvPr>
          <p:cNvSpPr/>
          <p:nvPr/>
        </p:nvSpPr>
        <p:spPr>
          <a:xfrm rot="3426325">
            <a:off x="6432098" y="4447531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" name="矢印: 右 42">
            <a:extLst>
              <a:ext uri="{FF2B5EF4-FFF2-40B4-BE49-F238E27FC236}">
                <a16:creationId xmlns:a16="http://schemas.microsoft.com/office/drawing/2014/main" id="{BCF7B86A-173A-5659-99EE-4416ADD81745}"/>
              </a:ext>
            </a:extLst>
          </p:cNvPr>
          <p:cNvSpPr/>
          <p:nvPr/>
        </p:nvSpPr>
        <p:spPr>
          <a:xfrm rot="7708484">
            <a:off x="6968302" y="4493927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矢印: 右 43">
            <a:extLst>
              <a:ext uri="{FF2B5EF4-FFF2-40B4-BE49-F238E27FC236}">
                <a16:creationId xmlns:a16="http://schemas.microsoft.com/office/drawing/2014/main" id="{E3CBCFAC-76C9-7A50-F892-C9857B354D72}"/>
              </a:ext>
            </a:extLst>
          </p:cNvPr>
          <p:cNvSpPr/>
          <p:nvPr/>
        </p:nvSpPr>
        <p:spPr>
          <a:xfrm rot="3426325">
            <a:off x="7688726" y="4471383"/>
            <a:ext cx="133463" cy="49712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5" name="矢印: 右 44">
            <a:extLst>
              <a:ext uri="{FF2B5EF4-FFF2-40B4-BE49-F238E27FC236}">
                <a16:creationId xmlns:a16="http://schemas.microsoft.com/office/drawing/2014/main" id="{257665AD-1D83-B2DE-7E2E-1F13C2BAEEA5}"/>
              </a:ext>
            </a:extLst>
          </p:cNvPr>
          <p:cNvSpPr/>
          <p:nvPr/>
        </p:nvSpPr>
        <p:spPr>
          <a:xfrm rot="7708484">
            <a:off x="8357192" y="4522232"/>
            <a:ext cx="122170" cy="54307"/>
          </a:xfrm>
          <a:prstGeom prst="rightArrow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9473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6</TotalTime>
  <Words>60</Words>
  <Application>Microsoft Office PowerPoint</Application>
  <PresentationFormat>ワイド画面</PresentationFormat>
  <Paragraphs>29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游ゴシック</vt:lpstr>
      <vt:lpstr>游ゴシック Light</vt:lpstr>
      <vt:lpstr>Arial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二村　学</dc:creator>
  <cp:lastModifiedBy>二村　学</cp:lastModifiedBy>
  <cp:revision>21</cp:revision>
  <dcterms:created xsi:type="dcterms:W3CDTF">2025-04-29T06:59:02Z</dcterms:created>
  <dcterms:modified xsi:type="dcterms:W3CDTF">2025-07-30T14:46:41Z</dcterms:modified>
</cp:coreProperties>
</file>